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4" r:id="rId3"/>
    <p:sldId id="265" r:id="rId4"/>
    <p:sldId id="262" r:id="rId5"/>
    <p:sldId id="263" r:id="rId6"/>
  </p:sldIdLst>
  <p:sldSz cx="6858000" cy="9144000" type="screen4x3"/>
  <p:notesSz cx="6769100" cy="9906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1902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13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46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339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061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003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472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701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829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070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44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323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650A8-DCD8-4A91-B9BE-C5DE50979C94}" type="datetimeFigureOut">
              <a:rPr lang="en-US" smtClean="0"/>
              <a:t>3/31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AB374-2557-423E-9DBF-C186EED5E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353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image" Target="../media/image18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12" Type="http://schemas.openxmlformats.org/officeDocument/2006/relationships/image" Target="../media/image17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11" Type="http://schemas.openxmlformats.org/officeDocument/2006/relationships/image" Target="../media/image16.emf"/><Relationship Id="rId5" Type="http://schemas.openxmlformats.org/officeDocument/2006/relationships/image" Target="../media/image10.emf"/><Relationship Id="rId10" Type="http://schemas.openxmlformats.org/officeDocument/2006/relationships/image" Target="../media/image15.emf"/><Relationship Id="rId4" Type="http://schemas.openxmlformats.org/officeDocument/2006/relationships/image" Target="../media/image9.emf"/><Relationship Id="rId9" Type="http://schemas.openxmlformats.org/officeDocument/2006/relationships/image" Target="../media/image14.emf"/><Relationship Id="rId14" Type="http://schemas.openxmlformats.org/officeDocument/2006/relationships/image" Target="../media/image19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13" Type="http://schemas.openxmlformats.org/officeDocument/2006/relationships/image" Target="../media/image31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12" Type="http://schemas.openxmlformats.org/officeDocument/2006/relationships/image" Target="../media/image30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11" Type="http://schemas.openxmlformats.org/officeDocument/2006/relationships/image" Target="../media/image29.emf"/><Relationship Id="rId5" Type="http://schemas.openxmlformats.org/officeDocument/2006/relationships/image" Target="../media/image23.emf"/><Relationship Id="rId10" Type="http://schemas.openxmlformats.org/officeDocument/2006/relationships/image" Target="../media/image28.emf"/><Relationship Id="rId4" Type="http://schemas.openxmlformats.org/officeDocument/2006/relationships/image" Target="../media/image22.emf"/><Relationship Id="rId9" Type="http://schemas.openxmlformats.org/officeDocument/2006/relationships/image" Target="../media/image27.emf"/><Relationship Id="rId14" Type="http://schemas.openxmlformats.org/officeDocument/2006/relationships/image" Target="../media/image3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071224" y="4038600"/>
            <a:ext cx="28055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22612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5"/>
          <p:cNvSpPr txBox="1"/>
          <p:nvPr/>
        </p:nvSpPr>
        <p:spPr>
          <a:xfrm>
            <a:off x="63790" y="0"/>
            <a:ext cx="2544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4522" y="2900254"/>
            <a:ext cx="2926080" cy="198514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55350" y="2969575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484392" y="398875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39694" y="542925"/>
            <a:ext cx="1359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ion mode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9647" y="2900253"/>
            <a:ext cx="2926080" cy="198514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135294" y="542925"/>
            <a:ext cx="12987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ion mod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193800" y="2969575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322842" y="398875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59647" y="897509"/>
            <a:ext cx="2926080" cy="1985145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192297" y="976305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76074" y="1995480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12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5966" y="892389"/>
            <a:ext cx="2926080" cy="1985145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2311785" y="974800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350297" y="1993975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12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9430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5"/>
          <p:cNvSpPr txBox="1"/>
          <p:nvPr/>
        </p:nvSpPr>
        <p:spPr>
          <a:xfrm>
            <a:off x="63790" y="0"/>
            <a:ext cx="2544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1066800"/>
            <a:ext cx="2743200" cy="182938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18" b="612"/>
          <a:stretch/>
        </p:blipFill>
        <p:spPr>
          <a:xfrm>
            <a:off x="3581400" y="1066799"/>
            <a:ext cx="2743200" cy="182938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800600" y="76199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28800" y="762000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12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84964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784578"/>
            <a:ext cx="1524000" cy="1866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2699103"/>
            <a:ext cx="1524000" cy="752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3505200"/>
            <a:ext cx="1524000" cy="533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784578"/>
            <a:ext cx="1524000" cy="752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1582795"/>
            <a:ext cx="1524000" cy="1247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2896778"/>
            <a:ext cx="1524000" cy="100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3973103"/>
            <a:ext cx="1524000" cy="1123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5182778"/>
            <a:ext cx="1524000" cy="1866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7140228"/>
            <a:ext cx="1524000" cy="100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200" y="784578"/>
            <a:ext cx="1524000" cy="752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200" y="1599967"/>
            <a:ext cx="1524000" cy="100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200" y="2677703"/>
            <a:ext cx="1524000" cy="5829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3525" y="784578"/>
            <a:ext cx="1524000" cy="5829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テキスト ボックス 15"/>
          <p:cNvSpPr txBox="1"/>
          <p:nvPr/>
        </p:nvSpPr>
        <p:spPr>
          <a:xfrm>
            <a:off x="63790" y="0"/>
            <a:ext cx="2544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838200" y="606609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035586" y="60660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199520" y="606609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396906" y="606609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572053" y="606609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453183" y="606609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650569" y="60660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814503" y="606609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011889" y="606609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187036" y="606609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053380" y="606609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250766" y="60660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414700" y="606609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612086" y="606609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787233" y="606609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628179" y="606609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825565" y="60660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989499" y="606609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186885" y="606609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362032" y="606609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正方形/長方形 37"/>
          <p:cNvSpPr/>
          <p:nvPr/>
        </p:nvSpPr>
        <p:spPr>
          <a:xfrm>
            <a:off x="5345776" y="6987884"/>
            <a:ext cx="1097280" cy="123587"/>
          </a:xfrm>
          <a:prstGeom prst="rect">
            <a:avLst/>
          </a:prstGeom>
          <a:gradFill flip="none" rotWithShape="1">
            <a:gsLst>
              <a:gs pos="0">
                <a:srgbClr val="00B050"/>
              </a:gs>
              <a:gs pos="50000">
                <a:schemeClr val="bg1"/>
              </a:gs>
              <a:gs pos="100000">
                <a:srgbClr val="FF0000"/>
              </a:gs>
            </a:gsLst>
            <a:lin ang="0" scaled="1"/>
            <a:tileRect/>
          </a:gra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6165256" y="6741744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gt; 2-fold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029200" y="6745235"/>
            <a:ext cx="6992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5-fold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61593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63790" y="0"/>
            <a:ext cx="2544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50" y="838200"/>
            <a:ext cx="1343025" cy="1866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50" y="2752725"/>
            <a:ext cx="1343025" cy="752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50" y="3559366"/>
            <a:ext cx="1343025" cy="533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329" y="838200"/>
            <a:ext cx="1343025" cy="752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329" y="1624644"/>
            <a:ext cx="1343025" cy="1247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329" y="2872419"/>
            <a:ext cx="1343025" cy="100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329" y="3872544"/>
            <a:ext cx="1343025" cy="1123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329" y="5019446"/>
            <a:ext cx="1343025" cy="1866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329" y="7010400"/>
            <a:ext cx="1343025" cy="100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1375" y="838200"/>
            <a:ext cx="1343025" cy="752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1375" y="1624644"/>
            <a:ext cx="1343025" cy="100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1375" y="2705100"/>
            <a:ext cx="1343025" cy="5829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9175" y="838200"/>
            <a:ext cx="1343025" cy="5829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正方形/長方形 15"/>
          <p:cNvSpPr/>
          <p:nvPr/>
        </p:nvSpPr>
        <p:spPr>
          <a:xfrm>
            <a:off x="4978270" y="6987884"/>
            <a:ext cx="1097280" cy="123587"/>
          </a:xfrm>
          <a:prstGeom prst="rect">
            <a:avLst/>
          </a:prstGeom>
          <a:gradFill flip="none" rotWithShape="1">
            <a:gsLst>
              <a:gs pos="0">
                <a:srgbClr val="00B050"/>
              </a:gs>
              <a:gs pos="50000">
                <a:schemeClr val="bg1"/>
              </a:gs>
              <a:gs pos="100000">
                <a:srgbClr val="FF0000"/>
              </a:gs>
            </a:gsLst>
            <a:lin ang="0" scaled="1"/>
            <a:tileRect/>
          </a:gra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797750" y="6741744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gt; 2-fold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661694" y="6745235"/>
            <a:ext cx="6992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5-fold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095446" y="67383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264186" y="67383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441770" y="67383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625506" y="67383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コネクタ 3"/>
          <p:cNvCxnSpPr/>
          <p:nvPr/>
        </p:nvCxnSpPr>
        <p:spPr>
          <a:xfrm>
            <a:off x="1143840" y="700872"/>
            <a:ext cx="3198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1508928" y="700872"/>
            <a:ext cx="3198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1508928" y="49907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086896" y="498232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8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8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525434" y="66797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694174" y="66797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864724" y="66797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055494" y="66797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線コネクタ 32"/>
          <p:cNvCxnSpPr/>
          <p:nvPr/>
        </p:nvCxnSpPr>
        <p:spPr>
          <a:xfrm>
            <a:off x="2573828" y="695008"/>
            <a:ext cx="3198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2938916" y="695008"/>
            <a:ext cx="3198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2938916" y="49320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516884" y="492368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8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8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28"/>
          <p:cNvSpPr txBox="1"/>
          <p:nvPr/>
        </p:nvSpPr>
        <p:spPr>
          <a:xfrm>
            <a:off x="3979480" y="65675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29"/>
          <p:cNvSpPr txBox="1"/>
          <p:nvPr/>
        </p:nvSpPr>
        <p:spPr>
          <a:xfrm>
            <a:off x="4148220" y="65675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30"/>
          <p:cNvSpPr txBox="1"/>
          <p:nvPr/>
        </p:nvSpPr>
        <p:spPr>
          <a:xfrm>
            <a:off x="4318770" y="65675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31"/>
          <p:cNvSpPr txBox="1"/>
          <p:nvPr/>
        </p:nvSpPr>
        <p:spPr>
          <a:xfrm>
            <a:off x="4509540" y="65675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線コネクタ 32"/>
          <p:cNvCxnSpPr/>
          <p:nvPr/>
        </p:nvCxnSpPr>
        <p:spPr>
          <a:xfrm>
            <a:off x="4027874" y="683788"/>
            <a:ext cx="3198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33"/>
          <p:cNvCxnSpPr/>
          <p:nvPr/>
        </p:nvCxnSpPr>
        <p:spPr>
          <a:xfrm>
            <a:off x="4392962" y="683788"/>
            <a:ext cx="3198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34"/>
          <p:cNvSpPr txBox="1"/>
          <p:nvPr/>
        </p:nvSpPr>
        <p:spPr>
          <a:xfrm>
            <a:off x="4392962" y="48198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35"/>
          <p:cNvSpPr txBox="1"/>
          <p:nvPr/>
        </p:nvSpPr>
        <p:spPr>
          <a:xfrm>
            <a:off x="3970930" y="481148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8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8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28"/>
          <p:cNvSpPr txBox="1"/>
          <p:nvPr/>
        </p:nvSpPr>
        <p:spPr>
          <a:xfrm>
            <a:off x="5406178" y="65675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29"/>
          <p:cNvSpPr txBox="1"/>
          <p:nvPr/>
        </p:nvSpPr>
        <p:spPr>
          <a:xfrm>
            <a:off x="5574918" y="65675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30"/>
          <p:cNvSpPr txBox="1"/>
          <p:nvPr/>
        </p:nvSpPr>
        <p:spPr>
          <a:xfrm>
            <a:off x="5745468" y="65675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31"/>
          <p:cNvSpPr txBox="1"/>
          <p:nvPr/>
        </p:nvSpPr>
        <p:spPr>
          <a:xfrm>
            <a:off x="5936238" y="65675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線コネクタ 32"/>
          <p:cNvCxnSpPr/>
          <p:nvPr/>
        </p:nvCxnSpPr>
        <p:spPr>
          <a:xfrm>
            <a:off x="5454572" y="683788"/>
            <a:ext cx="3198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33"/>
          <p:cNvCxnSpPr/>
          <p:nvPr/>
        </p:nvCxnSpPr>
        <p:spPr>
          <a:xfrm>
            <a:off x="5819660" y="683788"/>
            <a:ext cx="3198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34"/>
          <p:cNvSpPr txBox="1"/>
          <p:nvPr/>
        </p:nvSpPr>
        <p:spPr>
          <a:xfrm>
            <a:off x="5819660" y="48198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35"/>
          <p:cNvSpPr txBox="1"/>
          <p:nvPr/>
        </p:nvSpPr>
        <p:spPr>
          <a:xfrm>
            <a:off x="5397628" y="481148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8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8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8711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9</TotalTime>
  <Words>82</Words>
  <Application>Microsoft Office PowerPoint</Application>
  <PresentationFormat>On-screen Show (4:3)</PresentationFormat>
  <Paragraphs>6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ＭＳ Ｐゴシック</vt:lpstr>
      <vt:lpstr>Arial</vt:lpstr>
      <vt:lpstr>Calibri</vt:lpstr>
      <vt:lpstr>Times New Roman</vt:lpstr>
      <vt:lpstr>Office ​​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itok2</dc:creator>
  <cp:lastModifiedBy>saitok2</cp:lastModifiedBy>
  <cp:revision>52</cp:revision>
  <cp:lastPrinted>2015-11-11T02:03:41Z</cp:lastPrinted>
  <dcterms:created xsi:type="dcterms:W3CDTF">2015-11-04T06:22:09Z</dcterms:created>
  <dcterms:modified xsi:type="dcterms:W3CDTF">2016-03-31T02:05:10Z</dcterms:modified>
</cp:coreProperties>
</file>